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sldIdLst>
    <p:sldId id="257" r:id="rId2"/>
  </p:sldIdLst>
  <p:sldSz cx="12192000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7"/>
    <p:restoredTop sz="94665"/>
  </p:normalViewPr>
  <p:slideViewPr>
    <p:cSldViewPr snapToGrid="0">
      <p:cViewPr varScale="1">
        <p:scale>
          <a:sx n="46" d="100"/>
          <a:sy n="46" d="100"/>
        </p:scale>
        <p:origin x="332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945943"/>
            <a:ext cx="10363200" cy="626689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9454516"/>
            <a:ext cx="9144000" cy="4345992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F2D1F-3BBA-9A42-A153-1A39497F5466}" type="datetimeFigureOut">
              <a:rPr lang="en-US" smtClean="0"/>
              <a:t>6/2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DCED3-5CA9-6E43-B738-2D7961278B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77085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F2D1F-3BBA-9A42-A153-1A39497F5466}" type="datetimeFigureOut">
              <a:rPr lang="en-US" smtClean="0"/>
              <a:t>6/2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DCED3-5CA9-6E43-B738-2D7961278B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14910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958369"/>
            <a:ext cx="2628900" cy="1525473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958369"/>
            <a:ext cx="7734300" cy="1525473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F2D1F-3BBA-9A42-A153-1A39497F5466}" type="datetimeFigureOut">
              <a:rPr lang="en-US" smtClean="0"/>
              <a:t>6/2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DCED3-5CA9-6E43-B738-2D7961278B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16331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F2D1F-3BBA-9A42-A153-1A39497F5466}" type="datetimeFigureOut">
              <a:rPr lang="en-US" smtClean="0"/>
              <a:t>6/2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DCED3-5CA9-6E43-B738-2D7961278B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80913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487671"/>
            <a:ext cx="10515600" cy="7487774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2046282"/>
            <a:ext cx="10515600" cy="3937644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>
                    <a:tint val="82000"/>
                  </a:schemeClr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82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F2D1F-3BBA-9A42-A153-1A39497F5466}" type="datetimeFigureOut">
              <a:rPr lang="en-US" smtClean="0"/>
              <a:t>6/2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DCED3-5CA9-6E43-B738-2D7961278B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37176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791843"/>
            <a:ext cx="5181600" cy="1142125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791843"/>
            <a:ext cx="5181600" cy="1142125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F2D1F-3BBA-9A42-A153-1A39497F5466}" type="datetimeFigureOut">
              <a:rPr lang="en-US" smtClean="0"/>
              <a:t>6/29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DCED3-5CA9-6E43-B738-2D7961278B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21580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958373"/>
            <a:ext cx="10515600" cy="347929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4412664"/>
            <a:ext cx="5157787" cy="2162578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6575242"/>
            <a:ext cx="5157787" cy="967119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4412664"/>
            <a:ext cx="5183188" cy="2162578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6575242"/>
            <a:ext cx="5183188" cy="967119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F2D1F-3BBA-9A42-A153-1A39497F5466}" type="datetimeFigureOut">
              <a:rPr lang="en-US" smtClean="0"/>
              <a:t>6/29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DCED3-5CA9-6E43-B738-2D7961278B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35439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F2D1F-3BBA-9A42-A153-1A39497F5466}" type="datetimeFigureOut">
              <a:rPr lang="en-US" smtClean="0"/>
              <a:t>6/29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DCED3-5CA9-6E43-B738-2D7961278B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98536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F2D1F-3BBA-9A42-A153-1A39497F5466}" type="datetimeFigureOut">
              <a:rPr lang="en-US" smtClean="0"/>
              <a:t>6/29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DCED3-5CA9-6E43-B738-2D7961278B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20032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200044"/>
            <a:ext cx="3932237" cy="4200155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591766"/>
            <a:ext cx="6172200" cy="12792138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5400199"/>
            <a:ext cx="3932237" cy="10004536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F2D1F-3BBA-9A42-A153-1A39497F5466}" type="datetimeFigureOut">
              <a:rPr lang="en-US" smtClean="0"/>
              <a:t>6/29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DCED3-5CA9-6E43-B738-2D7961278B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90016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200044"/>
            <a:ext cx="3932237" cy="4200155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591766"/>
            <a:ext cx="6172200" cy="12792138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5400199"/>
            <a:ext cx="3932237" cy="10004536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3F2D1F-3BBA-9A42-A153-1A39497F5466}" type="datetimeFigureOut">
              <a:rPr lang="en-US" smtClean="0"/>
              <a:t>6/29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DCED3-5CA9-6E43-B738-2D7961278B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66160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958373"/>
            <a:ext cx="10515600" cy="347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791843"/>
            <a:ext cx="10515600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6683952"/>
            <a:ext cx="2743200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13F2D1F-3BBA-9A42-A153-1A39497F5466}" type="datetimeFigureOut">
              <a:rPr lang="en-US" smtClean="0"/>
              <a:t>6/2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6683952"/>
            <a:ext cx="4114800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6683952"/>
            <a:ext cx="2743200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E0DCED3-5CA9-6E43-B738-2D7961278B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97896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15C1AC1-04BF-2E63-7F09-FA1CBFED14B2}"/>
              </a:ext>
            </a:extLst>
          </p:cNvPr>
          <p:cNvSpPr txBox="1"/>
          <p:nvPr/>
        </p:nvSpPr>
        <p:spPr>
          <a:xfrm>
            <a:off x="-1111323" y="8207516"/>
            <a:ext cx="8244346" cy="11292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369" b="1" dirty="0">
                <a:latin typeface="Arial" panose="020B0604020202020204" pitchFamily="34" charset="0"/>
                <a:cs typeface="Arial" panose="020B0604020202020204" pitchFamily="34" charset="0"/>
              </a:rPr>
              <a:t>Edge effect </a:t>
            </a:r>
          </a:p>
          <a:p>
            <a:pPr algn="ctr"/>
            <a:r>
              <a:rPr lang="en-US" sz="3369" b="1" dirty="0">
                <a:latin typeface="Arial" panose="020B0604020202020204" pitchFamily="34" charset="0"/>
                <a:cs typeface="Arial" panose="020B0604020202020204" pitchFamily="34" charset="0"/>
              </a:rPr>
              <a:t>(No </a:t>
            </a:r>
            <a:r>
              <a:rPr lang="en-US" sz="3369" b="1" dirty="0" err="1">
                <a:latin typeface="Arial" panose="020B0604020202020204" pitchFamily="34" charset="0"/>
                <a:cs typeface="Arial" panose="020B0604020202020204" pitchFamily="34" charset="0"/>
              </a:rPr>
              <a:t>standardisation</a:t>
            </a:r>
            <a:r>
              <a:rPr lang="en-US" sz="3369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7970895-F26E-BF5D-1619-0D51E4D6C160}"/>
              </a:ext>
            </a:extLst>
          </p:cNvPr>
          <p:cNvSpPr txBox="1"/>
          <p:nvPr/>
        </p:nvSpPr>
        <p:spPr>
          <a:xfrm>
            <a:off x="4068952" y="8182182"/>
            <a:ext cx="8659947" cy="11292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369" b="1" dirty="0">
                <a:latin typeface="Arial" panose="020B0604020202020204" pitchFamily="34" charset="0"/>
                <a:cs typeface="Arial" panose="020B0604020202020204" pitchFamily="34" charset="0"/>
              </a:rPr>
              <a:t>Edge effect </a:t>
            </a:r>
          </a:p>
          <a:p>
            <a:pPr algn="ctr"/>
            <a:r>
              <a:rPr lang="en-US" sz="3369" b="1" dirty="0">
                <a:latin typeface="Arial" panose="020B0604020202020204" pitchFamily="34" charset="0"/>
                <a:cs typeface="Arial" panose="020B0604020202020204" pitchFamily="34" charset="0"/>
              </a:rPr>
              <a:t>(MW </a:t>
            </a:r>
            <a:r>
              <a:rPr lang="en-US" sz="3369" b="1" dirty="0" err="1">
                <a:latin typeface="Arial" panose="020B0604020202020204" pitchFamily="34" charset="0"/>
                <a:cs typeface="Arial" panose="020B0604020202020204" pitchFamily="34" charset="0"/>
              </a:rPr>
              <a:t>standardisation</a:t>
            </a:r>
            <a:r>
              <a:rPr lang="en-US" sz="3369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15F1082A-0CDD-BAAD-B60E-592F05AF995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17994"/>
          <a:stretch/>
        </p:blipFill>
        <p:spPr>
          <a:xfrm>
            <a:off x="3" y="9474890"/>
            <a:ext cx="5211781" cy="5296168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7ADC411E-292C-854A-A130-522E4B9403A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87625" y="9374451"/>
            <a:ext cx="6532084" cy="5443403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170450FE-CB85-CEA4-3F1F-1473FD2162D3}"/>
              </a:ext>
            </a:extLst>
          </p:cNvPr>
          <p:cNvSpPr txBox="1"/>
          <p:nvPr/>
        </p:nvSpPr>
        <p:spPr>
          <a:xfrm>
            <a:off x="0" y="15004785"/>
            <a:ext cx="12191997" cy="27084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3400" b="1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File 1.</a:t>
            </a:r>
            <a:r>
              <a:rPr lang="en-GB" sz="3400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(a) Amino acid profiles differ between domains of life as shown by principal component analysis and the </a:t>
            </a:r>
            <a:r>
              <a:rPr lang="en-GB" sz="3400" kern="100" dirty="0" err="1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Hausdorff</a:t>
            </a:r>
            <a:r>
              <a:rPr lang="en-GB" sz="3400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distance in non-standardised and molecular weight-standardised data. (b)Edge effect present in amino acid profiles for non-standardised and standardised by molecular weight models. </a:t>
            </a:r>
            <a:endParaRPr lang="en-GB" sz="3400" kern="100" dirty="0"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1AC9900D-7FC8-EEC7-2421-504ED8AB37D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21829" y="1117267"/>
            <a:ext cx="11055928" cy="6633557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346E99DC-FC32-A33A-3E55-9D6321FB30DD}"/>
              </a:ext>
            </a:extLst>
          </p:cNvPr>
          <p:cNvSpPr txBox="1"/>
          <p:nvPr/>
        </p:nvSpPr>
        <p:spPr>
          <a:xfrm rot="16200000">
            <a:off x="-3472768" y="4087585"/>
            <a:ext cx="766597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 MW standardization      No </a:t>
            </a:r>
            <a:r>
              <a:rPr lang="en-US" sz="2800" b="1" dirty="0" err="1">
                <a:latin typeface="Arial" panose="020B0604020202020204" pitchFamily="34" charset="0"/>
                <a:cs typeface="Arial" panose="020B0604020202020204" pitchFamily="34" charset="0"/>
              </a:rPr>
              <a:t>standardisation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F565B01-872E-B58F-69FC-97A9DF07E1B2}"/>
              </a:ext>
            </a:extLst>
          </p:cNvPr>
          <p:cNvSpPr txBox="1"/>
          <p:nvPr/>
        </p:nvSpPr>
        <p:spPr>
          <a:xfrm>
            <a:off x="3010850" y="332638"/>
            <a:ext cx="5615375" cy="6108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369" b="1" dirty="0">
                <a:latin typeface="Arial" panose="020B0604020202020204" pitchFamily="34" charset="0"/>
                <a:cs typeface="Arial" panose="020B0604020202020204" pitchFamily="34" charset="0"/>
              </a:rPr>
              <a:t>Amino acid profile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361B4FF-0EB4-A558-ED7E-E8F6437E6FF2}"/>
              </a:ext>
            </a:extLst>
          </p:cNvPr>
          <p:cNvSpPr txBox="1"/>
          <p:nvPr/>
        </p:nvSpPr>
        <p:spPr>
          <a:xfrm>
            <a:off x="0" y="0"/>
            <a:ext cx="30609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A206DBA-B791-9682-027E-0C6E584ABDEF}"/>
              </a:ext>
            </a:extLst>
          </p:cNvPr>
          <p:cNvSpPr txBox="1"/>
          <p:nvPr/>
        </p:nvSpPr>
        <p:spPr>
          <a:xfrm>
            <a:off x="98608" y="8312834"/>
            <a:ext cx="30609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</p:spTree>
    <p:extLst>
      <p:ext uri="{BB962C8B-B14F-4D97-AF65-F5344CB8AC3E}">
        <p14:creationId xmlns:p14="http://schemas.microsoft.com/office/powerpoint/2010/main" val="37568979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75</Words>
  <Application>Microsoft Macintosh PowerPoint</Application>
  <PresentationFormat>Custom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orimoto, Juliano</dc:creator>
  <cp:lastModifiedBy>Morimoto, Juliano</cp:lastModifiedBy>
  <cp:revision>1</cp:revision>
  <dcterms:created xsi:type="dcterms:W3CDTF">2024-06-29T18:19:03Z</dcterms:created>
  <dcterms:modified xsi:type="dcterms:W3CDTF">2024-06-29T18:26:03Z</dcterms:modified>
</cp:coreProperties>
</file>